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4"/>
  </p:sldMasterIdLst>
  <p:notesMasterIdLst>
    <p:notesMasterId r:id="rId6"/>
  </p:notesMasterIdLst>
  <p:sldIdLst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Author" initials="A" userId="Author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3" autoAdjust="0"/>
    <p:restoredTop sz="91162" autoAdjust="0"/>
  </p:normalViewPr>
  <p:slideViewPr>
    <p:cSldViewPr snapToGrid="0">
      <p:cViewPr varScale="1">
        <p:scale>
          <a:sx n="84" d="100"/>
          <a:sy n="84" d="100"/>
        </p:scale>
        <p:origin x="25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ne\OneDrive\Documents\Edanz\Assignments\08-August-2023\Due%20Thursday%2024%20August%20-%20J2307-183391-Med-Shionogi-Kojima-influenza-DB-MD-Manuscript_Development_1R\183391-Edanz_result_endpoints_above5y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nne\OneDrive\Documents\Edanz\Assignments\08-August-2023\Due%20Thursday%2024%20August%20-%20J2307-183391-Med-Shionogi-Kojima-influenza-DB-MD-Manuscript_Development_1R\183391-Edanz_result_endpoints_above5yo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5939353264727316E-2"/>
          <c:y val="0"/>
          <c:w val="0.87476457674750863"/>
          <c:h val="0.9618768975262002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x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Lbls>
            <c:dLbl>
              <c:idx val="0"/>
              <c:layout>
                <c:manualLayout>
                  <c:x val="-5.3612995480238027E-2"/>
                  <c:y val="1.7469391315779289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7D190B53-38B3-46BB-BE40-8E947DA50F70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962672811059908"/>
                      <c:h val="4.7492911485435094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22EB-416C-97E6-936A942ABBD4}"/>
                </c:ext>
              </c:extLst>
            </c:dLbl>
            <c:dLbl>
              <c:idx val="1"/>
              <c:layout>
                <c:manualLayout>
                  <c:x val="-0.17430615430355284"/>
                  <c:y val="3.4117236091767297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FB6880E6-91D7-494F-9628-434D6742E283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60577151776423366"/>
                      <c:h val="4.2883675774746291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22EB-416C-97E6-936A942ABBD4}"/>
                </c:ext>
              </c:extLst>
            </c:dLbl>
            <c:dLbl>
              <c:idx val="2"/>
              <c:layout>
                <c:manualLayout>
                  <c:x val="-0.12320610970715029"/>
                  <c:y val="2.854133114364376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740963C9-F440-4C93-8C45-27D908F3550C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3364129626876763"/>
                      <c:h val="4.2883675774746291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22EB-416C-97E6-936A942ABBD4}"/>
                </c:ext>
              </c:extLst>
            </c:dLbl>
            <c:dLbl>
              <c:idx val="3"/>
              <c:layout>
                <c:manualLayout>
                  <c:x val="-1.7239854318418357E-2"/>
                  <c:y val="3.0729992242329661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D137C51D-916F-4069-BA00-7D8CA26B90EC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1985877805856991"/>
                      <c:h val="4.2883675774746291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22EB-416C-97E6-936A942ABBD4}"/>
                </c:ext>
              </c:extLst>
            </c:dLbl>
            <c:dLbl>
              <c:idx val="4"/>
              <c:layout>
                <c:manualLayout>
                  <c:x val="3.4221792775382787E-2"/>
                  <c:y val="2.7914910605325076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749E1D28-D72F-4191-84D8-F466BA664F5B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52892039542143598"/>
                      <c:h val="4.2883675774746291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22EB-416C-97E6-936A942ABBD4}"/>
                </c:ext>
              </c:extLst>
            </c:dLbl>
            <c:dLbl>
              <c:idx val="5"/>
              <c:layout>
                <c:manualLayout>
                  <c:x val="3.1914300579753231E-2"/>
                  <c:y val="3.7058980977829393E-3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6B20FC53-96B7-4121-AC66-03359E7E7E40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1488590753679205"/>
                      <c:h val="4.2883675774746291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22EB-416C-97E6-936A942ABBD4}"/>
                </c:ext>
              </c:extLst>
            </c:dLbl>
            <c:dLbl>
              <c:idx val="6"/>
              <c:layout>
                <c:manualLayout>
                  <c:x val="-6.7393711907239487E-2"/>
                  <c:y val="3.2831549674041727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233E7DB5-C0CB-42A9-B287-FC01990AB719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3146870819087263"/>
                      <c:h val="4.1430677730042144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22EB-416C-97E6-936A942ABBD4}"/>
                </c:ext>
              </c:extLst>
            </c:dLbl>
            <c:dLbl>
              <c:idx val="7"/>
              <c:layout>
                <c:manualLayout>
                  <c:x val="2.4264159357811805E-2"/>
                  <c:y val="1.4152803422448164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BA0C6006-F4F1-43C2-9877-4824EAA0B028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627530845845102"/>
                      <c:h val="4.205219868709368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22EB-416C-97E6-936A942ABBD4}"/>
                </c:ext>
              </c:extLst>
            </c:dLbl>
            <c:dLbl>
              <c:idx val="8"/>
              <c:layout>
                <c:manualLayout>
                  <c:x val="2.4671844804519057E-2"/>
                  <c:y val="-1.3486097438154128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61F974EB-8627-4A9C-8720-5BC001F866FD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3757841534116249"/>
                      <c:h val="4.205219868709368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8-22EB-416C-97E6-936A942ABBD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figure_data!$K$2:$K$10</c:f>
                <c:numCache>
                  <c:formatCode>General</c:formatCode>
                  <c:ptCount val="9"/>
                  <c:pt idx="0">
                    <c:v>0.17999999999999997</c:v>
                  </c:pt>
                  <c:pt idx="1">
                    <c:v>0.37999999999999995</c:v>
                  </c:pt>
                  <c:pt idx="2">
                    <c:v>0.19</c:v>
                  </c:pt>
                  <c:pt idx="3">
                    <c:v>0.05</c:v>
                  </c:pt>
                  <c:pt idx="4">
                    <c:v>0.09</c:v>
                  </c:pt>
                  <c:pt idx="5">
                    <c:v>3.0000000000000002E-2</c:v>
                  </c:pt>
                  <c:pt idx="6">
                    <c:v>0.23000000000000004</c:v>
                  </c:pt>
                  <c:pt idx="7">
                    <c:v>0</c:v>
                  </c:pt>
                  <c:pt idx="8">
                    <c:v>0.03</c:v>
                  </c:pt>
                </c:numCache>
              </c:numRef>
            </c:plus>
            <c:minus>
              <c:numRef>
                <c:f>figure_data!$J$2:$J$10</c:f>
                <c:numCache>
                  <c:formatCode>General</c:formatCode>
                  <c:ptCount val="9"/>
                  <c:pt idx="0">
                    <c:v>0.18000000000000002</c:v>
                  </c:pt>
                  <c:pt idx="1">
                    <c:v>0.38</c:v>
                  </c:pt>
                  <c:pt idx="2">
                    <c:v>0.2</c:v>
                  </c:pt>
                  <c:pt idx="3">
                    <c:v>0.05</c:v>
                  </c:pt>
                  <c:pt idx="4">
                    <c:v>0.1</c:v>
                  </c:pt>
                  <c:pt idx="5">
                    <c:v>0.03</c:v>
                  </c:pt>
                  <c:pt idx="6">
                    <c:v>0.22</c:v>
                  </c:pt>
                  <c:pt idx="7">
                    <c:v>0</c:v>
                  </c:pt>
                  <c:pt idx="8">
                    <c:v>0.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figure_data!$F$2:$F$10</c:f>
              <c:numCache>
                <c:formatCode>0.00_ </c:formatCode>
                <c:ptCount val="9"/>
                <c:pt idx="0">
                  <c:v>0.17</c:v>
                </c:pt>
                <c:pt idx="1">
                  <c:v>0.19</c:v>
                </c:pt>
                <c:pt idx="2">
                  <c:v>0.33</c:v>
                </c:pt>
                <c:pt idx="3">
                  <c:v>0.05</c:v>
                </c:pt>
                <c:pt idx="4">
                  <c:v>0.02</c:v>
                </c:pt>
                <c:pt idx="5">
                  <c:v>0.02</c:v>
                </c:pt>
                <c:pt idx="6">
                  <c:v>0.32</c:v>
                </c:pt>
                <c:pt idx="7">
                  <c:v>0</c:v>
                </c:pt>
                <c:pt idx="8">
                  <c:v>0</c:v>
                </c:pt>
              </c:numCache>
            </c:numRef>
          </c:xVal>
          <c:yVal>
            <c:numRef>
              <c:f>figure_data!$I$2:$I$10</c:f>
              <c:numCache>
                <c:formatCode>General</c:formatCode>
                <c:ptCount val="9"/>
                <c:pt idx="0">
                  <c:v>9</c:v>
                </c:pt>
                <c:pt idx="1">
                  <c:v>7</c:v>
                </c:pt>
                <c:pt idx="2">
                  <c:v>2</c:v>
                </c:pt>
                <c:pt idx="3">
                  <c:v>4</c:v>
                </c:pt>
                <c:pt idx="4">
                  <c:v>6</c:v>
                </c:pt>
                <c:pt idx="5">
                  <c:v>3</c:v>
                </c:pt>
                <c:pt idx="6">
                  <c:v>8</c:v>
                </c:pt>
                <c:pt idx="7">
                  <c:v>5</c:v>
                </c:pt>
                <c:pt idx="8">
                  <c:v>1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figure_data!$M$2:$M$10</c15:f>
                <c15:dlblRangeCache>
                  <c:ptCount val="9"/>
                  <c:pt idx="0">
                    <c:v>0.17 (-0.01–0.35) </c:v>
                  </c:pt>
                  <c:pt idx="1">
                    <c:v>0.19 (-0.19–0.57) </c:v>
                  </c:pt>
                  <c:pt idx="2">
                    <c:v>0.33 (0.13–0.52) </c:v>
                  </c:pt>
                  <c:pt idx="3">
                    <c:v>0.05 (0.00–0.10) </c:v>
                  </c:pt>
                  <c:pt idx="4">
                    <c:v>0.02 (-0.08–0.11) </c:v>
                  </c:pt>
                  <c:pt idx="5">
                    <c:v>0.02 (-0.01–0.05) </c:v>
                  </c:pt>
                  <c:pt idx="6">
                    <c:v>0.32 (0.10–0.55) </c:v>
                  </c:pt>
                  <c:pt idx="7">
                    <c:v>0.00 (0.00–0.00) </c:v>
                  </c:pt>
                  <c:pt idx="8">
                    <c:v>0.00 (-0.04–0.03) 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9-22EB-416C-97E6-936A942ABBD4}"/>
            </c:ext>
          </c:extLst>
        </c:ser>
        <c:ser>
          <c:idx val="1"/>
          <c:order val="1"/>
          <c:tx>
            <c:v>v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xVal>
            <c:numRef>
              <c:f>figure_data!$L$1:$L$11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xVal>
          <c:yVal>
            <c:numRef>
              <c:f>figure_data!$I$1:$I$11</c:f>
              <c:numCache>
                <c:formatCode>General</c:formatCode>
                <c:ptCount val="11"/>
                <c:pt idx="0">
                  <c:v>10</c:v>
                </c:pt>
                <c:pt idx="1">
                  <c:v>9</c:v>
                </c:pt>
                <c:pt idx="2">
                  <c:v>7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3</c:v>
                </c:pt>
                <c:pt idx="7">
                  <c:v>8</c:v>
                </c:pt>
                <c:pt idx="8">
                  <c:v>5</c:v>
                </c:pt>
                <c:pt idx="9">
                  <c:v>1</c:v>
                </c:pt>
                <c:pt idx="1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22EB-416C-97E6-936A942ABBD4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538840352"/>
        <c:axId val="538842976"/>
      </c:scatterChart>
      <c:valAx>
        <c:axId val="538840352"/>
        <c:scaling>
          <c:orientation val="minMax"/>
          <c:max val="0.8"/>
          <c:min val="-0.2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 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8842976"/>
        <c:crosses val="autoZero"/>
        <c:crossBetween val="midCat"/>
      </c:valAx>
      <c:valAx>
        <c:axId val="538842976"/>
        <c:scaling>
          <c:orientation val="minMax"/>
          <c:max val="9.3000000000000007"/>
          <c:min val="0.8"/>
        </c:scaling>
        <c:delete val="1"/>
        <c:axPos val="l"/>
        <c:numFmt formatCode="General" sourceLinked="1"/>
        <c:majorTickMark val="out"/>
        <c:minorTickMark val="none"/>
        <c:tickLblPos val="nextTo"/>
        <c:crossAx val="538840352"/>
        <c:crosses val="autoZero"/>
        <c:crossBetween val="midCat"/>
      </c:valAx>
      <c:spPr>
        <a:solidFill>
          <a:schemeClr val="bg1"/>
        </a:solidFill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6707674733045981E-2"/>
          <c:y val="0"/>
          <c:w val="0.90147472760909197"/>
          <c:h val="0.9546437209112468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x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Lbls>
            <c:dLbl>
              <c:idx val="0"/>
              <c:layout>
                <c:manualLayout>
                  <c:x val="9.4452020680619406E-2"/>
                  <c:y val="3.3423278236645509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7E8457DB-6AED-4C79-B01A-68D2E7CB99D9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numFmt formatCode="#,##0.00_);[Red]\(#,##0.00\)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1990640778814459"/>
                      <c:h val="4.1088372973696871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02CD-425F-B518-231DDE50C97C}"/>
                </c:ext>
              </c:extLst>
            </c:dLbl>
            <c:dLbl>
              <c:idx val="1"/>
              <c:layout>
                <c:manualLayout>
                  <c:x val="3.9920557235584291E-2"/>
                  <c:y val="1.0170742880443598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540A8A1C-E0D3-4F7F-BC39-F6FB5BE64903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numFmt formatCode="#,##0.00_);[Red]\(#,##0.00\)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7423550709260267"/>
                      <c:h val="5.7242648668853147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02CD-425F-B518-231DDE50C97C}"/>
                </c:ext>
              </c:extLst>
            </c:dLbl>
            <c:dLbl>
              <c:idx val="2"/>
              <c:layout>
                <c:manualLayout>
                  <c:x val="-7.9273762989621688E-2"/>
                  <c:y val="-3.7530162067907109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DDC5CE8A-6A02-4965-9FBA-7D1758904028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numFmt formatCode="#,##0.00_);[Red]\(#,##0.00\)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779363178710288"/>
                      <c:h val="5.9550402339589761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02CD-425F-B518-231DDE50C97C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D98D9629-0114-4966-96F4-C52044317CDE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02CD-425F-B518-231DDE50C97C}"/>
                </c:ext>
              </c:extLst>
            </c:dLbl>
            <c:dLbl>
              <c:idx val="4"/>
              <c:layout>
                <c:manualLayout>
                  <c:x val="6.2028346938942325E-2"/>
                  <c:y val="4.4417443928400031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D8FD7664-A121-4F0D-85FC-790895576B4F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numFmt formatCode="#,##0.00_);[Red]\(#,##0.00\)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8068977204565777"/>
                      <c:h val="5.7242648668853147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02CD-425F-B518-231DDE50C97C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0C046060-984C-4EA2-B87A-171CA1C7C4A3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02CD-425F-B518-231DDE50C97C}"/>
                </c:ext>
              </c:extLst>
            </c:dLbl>
            <c:dLbl>
              <c:idx val="6"/>
              <c:layout>
                <c:manualLayout>
                  <c:x val="0.14868280906584733"/>
                  <c:y val="1.6891030597361106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9EE20746-0D66-48F9-9BEA-2F819CCBDA53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numFmt formatCode="#,##0.00_);[Red]\(#,##0.00\)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5696450351976847"/>
                      <c:h val="5.2627141327379924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02CD-425F-B518-231DDE50C97C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endParaRPr lang="ja-JP" altLang="en-US"/>
                  </a:p>
                </c:rich>
              </c:tx>
              <c:dLblPos val="b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7-02CD-425F-B518-231DDE50C97C}"/>
                </c:ext>
              </c:extLst>
            </c:dLbl>
            <c:dLbl>
              <c:idx val="8"/>
              <c:layout>
                <c:manualLayout>
                  <c:x val="0.15010010550261116"/>
                  <c:y val="-2.936116835571841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3F734E60-4153-472E-A4CC-C002BC1D82B3}" type="CELLRANGE">
                      <a:rPr lang="en-US" altLang="ja-JP"/>
                      <a:pPr>
                        <a:defRPr lang="ja-JP"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CELLRANGE]</a:t>
                    </a:fld>
                    <a:endParaRPr lang="ja-JP" altLang="en-US"/>
                  </a:p>
                </c:rich>
              </c:tx>
              <c:numFmt formatCode="#,##0.00_);[Red]\(#,##0.00\)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40987586049139946"/>
                      <c:h val="4.351551520540619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8-02CD-425F-B518-231DDE50C97C}"/>
                </c:ext>
              </c:extLst>
            </c:dLbl>
            <c:numFmt formatCode="#,##0.00_);[Red]\(#,##0.00\)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b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0"/>
              </c:ext>
            </c:extLst>
          </c:dLbls>
          <c:errBars>
            <c:errDir val="x"/>
            <c:errBarType val="both"/>
            <c:errValType val="cust"/>
            <c:noEndCap val="0"/>
            <c:plus>
              <c:numRef>
                <c:f>figure_data!$P$2:$P$10</c:f>
                <c:numCache>
                  <c:formatCode>General</c:formatCode>
                  <c:ptCount val="9"/>
                  <c:pt idx="0">
                    <c:v>2.4499999999999997</c:v>
                  </c:pt>
                  <c:pt idx="1">
                    <c:v>0.51</c:v>
                  </c:pt>
                  <c:pt idx="2">
                    <c:v>2.6899999999999995</c:v>
                  </c:pt>
                  <c:pt idx="4">
                    <c:v>4.1500000000000004</c:v>
                  </c:pt>
                  <c:pt idx="6">
                    <c:v>2.1799999999999997</c:v>
                  </c:pt>
                  <c:pt idx="8">
                    <c:v>10.579999999999998</c:v>
                  </c:pt>
                </c:numCache>
              </c:numRef>
            </c:plus>
            <c:minus>
              <c:numRef>
                <c:f>figure_data!$O$2:$O$10</c:f>
                <c:numCache>
                  <c:formatCode>General</c:formatCode>
                  <c:ptCount val="9"/>
                  <c:pt idx="0">
                    <c:v>1.0899999999999999</c:v>
                  </c:pt>
                  <c:pt idx="1">
                    <c:v>0.36</c:v>
                  </c:pt>
                  <c:pt idx="2">
                    <c:v>1.3600000000000003</c:v>
                  </c:pt>
                  <c:pt idx="4">
                    <c:v>0.97</c:v>
                  </c:pt>
                  <c:pt idx="6">
                    <c:v>1.1000000000000003</c:v>
                  </c:pt>
                  <c:pt idx="8">
                    <c:v>0.669999999999999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figure_data!$C$2:$C$10</c:f>
              <c:numCache>
                <c:formatCode>0.00_ </c:formatCode>
                <c:ptCount val="9"/>
                <c:pt idx="0">
                  <c:v>1.98</c:v>
                </c:pt>
                <c:pt idx="1">
                  <c:v>1.19</c:v>
                </c:pt>
                <c:pt idx="2">
                  <c:v>2.74</c:v>
                </c:pt>
                <c:pt idx="4">
                  <c:v>1.26</c:v>
                </c:pt>
                <c:pt idx="6">
                  <c:v>2.2400000000000002</c:v>
                </c:pt>
                <c:pt idx="8">
                  <c:v>0.71</c:v>
                </c:pt>
              </c:numCache>
            </c:numRef>
          </c:xVal>
          <c:yVal>
            <c:numRef>
              <c:f>figure_data!$I$2:$I$10</c:f>
              <c:numCache>
                <c:formatCode>General</c:formatCode>
                <c:ptCount val="9"/>
                <c:pt idx="0">
                  <c:v>9</c:v>
                </c:pt>
                <c:pt idx="1">
                  <c:v>7</c:v>
                </c:pt>
                <c:pt idx="2">
                  <c:v>2</c:v>
                </c:pt>
                <c:pt idx="3">
                  <c:v>4</c:v>
                </c:pt>
                <c:pt idx="4">
                  <c:v>6</c:v>
                </c:pt>
                <c:pt idx="5">
                  <c:v>3</c:v>
                </c:pt>
                <c:pt idx="6">
                  <c:v>8</c:v>
                </c:pt>
                <c:pt idx="7">
                  <c:v>5</c:v>
                </c:pt>
                <c:pt idx="8">
                  <c:v>1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figure_data!$N$2:$N$10</c15:f>
                <c15:dlblRangeCache>
                  <c:ptCount val="9"/>
                  <c:pt idx="0">
                    <c:v>1.98 (0.89–4.43) </c:v>
                  </c:pt>
                  <c:pt idx="1">
                    <c:v>1.19 (0.83–1.70) </c:v>
                  </c:pt>
                  <c:pt idx="2">
                    <c:v>2.74 (1.38–5.43) </c:v>
                  </c:pt>
                  <c:pt idx="4">
                    <c:v>1.26 (0.29–5.41) </c:v>
                  </c:pt>
                  <c:pt idx="6">
                    <c:v>2.24 (1.14–4.42) </c:v>
                  </c:pt>
                  <c:pt idx="8">
                    <c:v>0.71 (0.04–11.29) 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9-02CD-425F-B518-231DDE50C97C}"/>
            </c:ext>
          </c:extLst>
        </c:ser>
        <c:ser>
          <c:idx val="1"/>
          <c:order val="1"/>
          <c:tx>
            <c:v>vline</c:v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xVal>
            <c:numRef>
              <c:f>figure_data!$Q$1:$Q$11</c:f>
              <c:numCache>
                <c:formatCode>General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</c:numCache>
            </c:numRef>
          </c:xVal>
          <c:yVal>
            <c:numRef>
              <c:f>figure_data!$I$1:$I$11</c:f>
              <c:numCache>
                <c:formatCode>General</c:formatCode>
                <c:ptCount val="11"/>
                <c:pt idx="0">
                  <c:v>10</c:v>
                </c:pt>
                <c:pt idx="1">
                  <c:v>9</c:v>
                </c:pt>
                <c:pt idx="2">
                  <c:v>7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3</c:v>
                </c:pt>
                <c:pt idx="7">
                  <c:v>8</c:v>
                </c:pt>
                <c:pt idx="8">
                  <c:v>5</c:v>
                </c:pt>
                <c:pt idx="9">
                  <c:v>1</c:v>
                </c:pt>
                <c:pt idx="10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02CD-425F-B518-231DDE50C97C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538840352"/>
        <c:axId val="538842976"/>
      </c:scatterChart>
      <c:valAx>
        <c:axId val="538840352"/>
        <c:scaling>
          <c:logBase val="2"/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 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38842976"/>
        <c:crosses val="autoZero"/>
        <c:crossBetween val="midCat"/>
        <c:majorUnit val="1"/>
      </c:valAx>
      <c:valAx>
        <c:axId val="538842976"/>
        <c:scaling>
          <c:orientation val="minMax"/>
          <c:max val="9.3000000000000007"/>
          <c:min val="0.60000000000000009"/>
        </c:scaling>
        <c:delete val="1"/>
        <c:axPos val="l"/>
        <c:numFmt formatCode="General" sourceLinked="1"/>
        <c:majorTickMark val="out"/>
        <c:minorTickMark val="none"/>
        <c:tickLblPos val="nextTo"/>
        <c:crossAx val="5388403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59D974-1385-4604-A990-8F1BF8C1E3FE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82D535-2FEA-40C5-9AD3-E84E375B9B66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451198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82D535-2FEA-40C5-9AD3-E84E375B9B66}" type="slidenum">
              <a:rPr lang="en-NZ" smtClean="0"/>
              <a:t>1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510180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609DDA-4C05-31E9-60B9-81CDE45358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8BA519-1F82-3EB1-3ED9-F01E94E541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6BCC45-1A13-EA98-C5B8-5BBE1A89C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D88F91-D9F9-01D5-6C6A-E392994A9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2E1645-49B0-D31E-3DAA-C06E96D9B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51800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64FF8-4635-1933-FA55-3082FBB1FE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007172-C6E3-3B1C-9B45-B08B5817FF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4613A3-120D-D737-DFD6-DBF92D443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4E963B-0DF6-21E7-0919-CB22097DE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DBA17C-F11D-7B17-EE20-0858A7F72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287177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724B5EA-67D6-609E-F7EE-0E3191D0B8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AD1F25-D046-9996-AA22-09CC1118F1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1DD219-2606-134D-55E8-BEB79BC922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71BF8E-04F6-B370-149C-DE48B6574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06907B-3472-F46A-D4E2-9FF79EC90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51646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CB91F-B348-7BB0-31F4-DA1D6AFE4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E885A6-30D0-2FC9-4A03-7B92D165FE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65E4D-6BF4-CFA4-BB00-333F749A3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C1A6B9-994A-B1D4-AA54-FEF87D4ED2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76DB7B-3EC3-631F-F388-DA37202C7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13073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5D168-7EC7-2814-18E9-F53257C953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E0DCA4-4D27-CAAF-A2E6-4002C171F0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5FDE8D-295D-D26B-3189-3B61C8970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0BBAD4-D18D-08F3-B5CD-1D322B1BD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EBD881-7D2A-5D83-36DB-1E5FBF3C9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10498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2808AF-8A94-A599-D1F6-94B479DCE7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F3F373-4F72-C4DA-F4F0-CE10A20CE1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B6D996-13B6-5A77-3446-B84522CE5A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39BF76-FC56-733B-F4D5-0B59038F9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6DA5EA-23E8-1F20-B64E-862EE7001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DA4EE1-13A2-03FD-0F87-29398F3ED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08826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60177-4756-A6CF-3A66-BBD15E199D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C40F23-1DDA-F817-4218-84E9330CCF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FA4224-2CF8-94B9-B9F8-934F2DB3A6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A3DCBB-5F61-270C-A1AC-7829271BBA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448BE2-C8ED-24DA-807D-46821E254E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B879D0F-7819-6C5F-7559-4B3B8F497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C020FA-EDA7-8BA8-907D-2B8A89A73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32E6DD-15AC-10C9-1890-92EF68E88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506929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E3E768-A540-8A32-748C-11437CA5CE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2C759E-3442-18E1-FEB6-6B02C9E39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0CAA4A-B524-24E0-1A84-3E58A7E9F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1614EA-FC75-2547-3622-2D6318BA9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99938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B2C44B-311E-1523-CDB0-497B3E3B5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20E523-F10B-4C2A-3E25-F2ED62426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4BEF94-7104-2C47-CAA8-C3BA023FC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99310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700DA2-E4BB-A06A-5319-F15BE5DE0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95F1F0-C56C-9746-7AC8-79E89B5BC6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5E366F-EC4A-8E60-147D-C455D775E7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AC3EA8-B743-4A66-BFC8-4044A665C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EE42F7-AD66-6793-6F3B-267561ECA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14B899-C3B7-D639-52EE-68CEEA0AA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023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8463F0-F8A0-7F59-FC1F-9EE4C435D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E5C921-07D2-5A2B-0A01-778F67EE67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436820-D6DD-8727-6270-650F1EEC63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365BB1-065A-37ED-A9CA-1C194AB08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602B18-2C1A-ADA7-077D-584AC4B85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3C095F-FC1D-501F-2BDB-F4701830C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652104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F9730D-2C5A-B681-59DB-51C3D820B5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188677-90E4-0042-FBC7-F7ECE75411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A6CA73-2848-6A72-6DFC-A38EC7EE1E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26DF77-9EA2-4D9F-9E1E-47416D5F509B}" type="datetimeFigureOut">
              <a:rPr lang="en-NZ" smtClean="0"/>
              <a:t>20/08/2024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4DAD92-30F4-2CA0-52D5-441183EAA2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CE3EF0-DF2F-3132-E4EA-E0CB0187E4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24203-8D09-43D9-AEFB-2ACBC2DE9EAD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38231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グラフ 5">
            <a:extLst>
              <a:ext uri="{FF2B5EF4-FFF2-40B4-BE49-F238E27FC236}">
                <a16:creationId xmlns:a16="http://schemas.microsoft.com/office/drawing/2014/main" id="{67EB98FD-36EE-4ED9-8FDE-4A5D832769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6113384"/>
              </p:ext>
            </p:extLst>
          </p:nvPr>
        </p:nvGraphicFramePr>
        <p:xfrm>
          <a:off x="8954694" y="975250"/>
          <a:ext cx="2690800" cy="4332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6">
            <a:extLst>
              <a:ext uri="{FF2B5EF4-FFF2-40B4-BE49-F238E27FC236}">
                <a16:creationId xmlns:a16="http://schemas.microsoft.com/office/drawing/2014/main" id="{5DE9BBFE-21E6-412F-AFDC-1DD9E18114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2063978"/>
              </p:ext>
            </p:extLst>
          </p:nvPr>
        </p:nvGraphicFramePr>
        <p:xfrm>
          <a:off x="6419765" y="925894"/>
          <a:ext cx="2690802" cy="43813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" name="表 3">
            <a:extLst>
              <a:ext uri="{FF2B5EF4-FFF2-40B4-BE49-F238E27FC236}">
                <a16:creationId xmlns:a16="http://schemas.microsoft.com/office/drawing/2014/main" id="{6CE14E9F-6329-C14F-04DA-48A2FEABCC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6387389"/>
              </p:ext>
            </p:extLst>
          </p:nvPr>
        </p:nvGraphicFramePr>
        <p:xfrm>
          <a:off x="403328" y="609223"/>
          <a:ext cx="11277600" cy="4469814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499856">
                  <a:extLst>
                    <a:ext uri="{9D8B030D-6E8A-4147-A177-3AD203B41FA5}">
                      <a16:colId xmlns:a16="http://schemas.microsoft.com/office/drawing/2014/main" val="989165373"/>
                    </a:ext>
                  </a:extLst>
                </a:gridCol>
                <a:gridCol w="1144002">
                  <a:extLst>
                    <a:ext uri="{9D8B030D-6E8A-4147-A177-3AD203B41FA5}">
                      <a16:colId xmlns:a16="http://schemas.microsoft.com/office/drawing/2014/main" val="95247281"/>
                    </a:ext>
                  </a:extLst>
                </a:gridCol>
                <a:gridCol w="1177910">
                  <a:extLst>
                    <a:ext uri="{9D8B030D-6E8A-4147-A177-3AD203B41FA5}">
                      <a16:colId xmlns:a16="http://schemas.microsoft.com/office/drawing/2014/main" val="3480520499"/>
                    </a:ext>
                  </a:extLst>
                </a:gridCol>
                <a:gridCol w="1244268">
                  <a:extLst>
                    <a:ext uri="{9D8B030D-6E8A-4147-A177-3AD203B41FA5}">
                      <a16:colId xmlns:a16="http://schemas.microsoft.com/office/drawing/2014/main" val="1495329896"/>
                    </a:ext>
                  </a:extLst>
                </a:gridCol>
                <a:gridCol w="2605782">
                  <a:extLst>
                    <a:ext uri="{9D8B030D-6E8A-4147-A177-3AD203B41FA5}">
                      <a16:colId xmlns:a16="http://schemas.microsoft.com/office/drawing/2014/main" val="4095209591"/>
                    </a:ext>
                  </a:extLst>
                </a:gridCol>
                <a:gridCol w="2605782">
                  <a:extLst>
                    <a:ext uri="{9D8B030D-6E8A-4147-A177-3AD203B41FA5}">
                      <a16:colId xmlns:a16="http://schemas.microsoft.com/office/drawing/2014/main" val="739743410"/>
                    </a:ext>
                  </a:extLst>
                </a:gridCol>
              </a:tblGrid>
              <a:tr h="16847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Endpoi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Treatme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Unadjusted</a:t>
                      </a:r>
                      <a:b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</a:br>
                      <a: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% (n/N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djusted by IPTW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8915975"/>
                  </a:ext>
                </a:extLst>
              </a:tr>
              <a:tr h="16847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% (n/N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Risk ratio (95% CI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Risk difference (95% CI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2024286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Hospitaliza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7 (8/4741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8 (22.9/13067.1)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165179738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36 (30/8359)</a:t>
                      </a:r>
                    </a:p>
                  </a:txBody>
                  <a:tcPr marL="6350" marR="6350" marT="635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35 (45.4/13108.6)</a:t>
                      </a:r>
                    </a:p>
                  </a:txBody>
                  <a:tcPr marL="6350" marR="6350" marT="635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8684179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dditional anti-influenza therap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3 (11/474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6 (34.0/13067.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67364595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63 (53/835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8 (76.6/13108.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022717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ntibacterial injec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99 (47/474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1 (131.4/13067.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70457988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20 (101/835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19 (156.4/13108.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53031272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Antibacterial injection for pneumon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6 (3/474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6 (8.0/13067.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27415430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7 (6/835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8 (10.1/13108.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43937935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Hospitalization for heart failur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 (0/474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9 (0.0/13067.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93301923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 (0/835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1 (0.0/13108.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5397899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Hospitalization for pneumon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 (0/474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 (0.0/13067.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2322732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5 (4/835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5 (6.3/13108.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5512736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xygen inhalation for pneumon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 (0/474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0 (0.0/13067.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8829137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2 (2/835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2 (3.0/13108.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90784403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Pneumoni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23 (11/474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19 (24.5/13067.1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34186040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4 (45/8359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51 (67.2/13108.6)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09223465"/>
                  </a:ext>
                </a:extLst>
              </a:tr>
              <a:tr h="2296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Meningiti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BXM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2 (1/4741)</a:t>
                      </a:r>
                    </a:p>
                  </a:txBody>
                  <a:tcPr marL="6350" marR="6350" marT="635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1 (1.8/13067.1)</a:t>
                      </a:r>
                    </a:p>
                  </a:txBody>
                  <a:tcPr marL="6350" marR="6350" marT="635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31754117"/>
                  </a:ext>
                </a:extLst>
              </a:tr>
              <a:tr h="22960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OT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1 (1/8359)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0.01 (1.3/13108.6)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517290"/>
                  </a:ext>
                </a:extLst>
              </a:tr>
            </a:tbl>
          </a:graphicData>
        </a:graphic>
      </p:graphicFrame>
      <p:sp>
        <p:nvSpPr>
          <p:cNvPr id="5" name="テキスト ボックス 9">
            <a:extLst>
              <a:ext uri="{FF2B5EF4-FFF2-40B4-BE49-F238E27FC236}">
                <a16:creationId xmlns:a16="http://schemas.microsoft.com/office/drawing/2014/main" id="{865844FF-BF0C-3F6F-2110-6650277C7981}"/>
              </a:ext>
            </a:extLst>
          </p:cNvPr>
          <p:cNvSpPr txBox="1"/>
          <p:nvPr/>
        </p:nvSpPr>
        <p:spPr>
          <a:xfrm>
            <a:off x="6478522" y="5663199"/>
            <a:ext cx="140763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r"/>
            <a:r>
              <a:rPr kumimoji="1" lang="en-US" altLang="ja-JP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 risk with OTV</a:t>
            </a:r>
            <a:endParaRPr kumimoji="1" lang="ja-JP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11">
            <a:extLst>
              <a:ext uri="{FF2B5EF4-FFF2-40B4-BE49-F238E27FC236}">
                <a16:creationId xmlns:a16="http://schemas.microsoft.com/office/drawing/2014/main" id="{7F78F845-4075-FCAF-8337-BF9708144FDD}"/>
              </a:ext>
            </a:extLst>
          </p:cNvPr>
          <p:cNvSpPr txBox="1"/>
          <p:nvPr/>
        </p:nvSpPr>
        <p:spPr>
          <a:xfrm>
            <a:off x="7898609" y="5647540"/>
            <a:ext cx="1521396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kumimoji="1" lang="en-US" altLang="ja-JP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 risk with BXM</a:t>
            </a:r>
            <a:endParaRPr kumimoji="1" lang="ja-JP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AC6CA201-5228-FC1B-0F20-E4C44464E40C}"/>
              </a:ext>
            </a:extLst>
          </p:cNvPr>
          <p:cNvSpPr/>
          <p:nvPr/>
        </p:nvSpPr>
        <p:spPr>
          <a:xfrm>
            <a:off x="8029783" y="5523353"/>
            <a:ext cx="211396" cy="52738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C3873372-39FF-5E04-9B12-A48AAAE88BA7}"/>
              </a:ext>
            </a:extLst>
          </p:cNvPr>
          <p:cNvSpPr/>
          <p:nvPr/>
        </p:nvSpPr>
        <p:spPr>
          <a:xfrm rot="10800000">
            <a:off x="7573210" y="5522353"/>
            <a:ext cx="211396" cy="5273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17" name="テキスト ボックス 9">
            <a:extLst>
              <a:ext uri="{FF2B5EF4-FFF2-40B4-BE49-F238E27FC236}">
                <a16:creationId xmlns:a16="http://schemas.microsoft.com/office/drawing/2014/main" id="{27D6BCCC-648F-9696-F844-ABFACFC8A6FA}"/>
              </a:ext>
            </a:extLst>
          </p:cNvPr>
          <p:cNvSpPr txBox="1"/>
          <p:nvPr/>
        </p:nvSpPr>
        <p:spPr>
          <a:xfrm>
            <a:off x="8540560" y="5444487"/>
            <a:ext cx="1521396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r"/>
            <a:r>
              <a:rPr kumimoji="1" lang="en-US" altLang="ja-JP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 risk with OTV</a:t>
            </a:r>
            <a:endParaRPr kumimoji="1" lang="ja-JP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1">
            <a:extLst>
              <a:ext uri="{FF2B5EF4-FFF2-40B4-BE49-F238E27FC236}">
                <a16:creationId xmlns:a16="http://schemas.microsoft.com/office/drawing/2014/main" id="{23F8B23B-8E9C-1D46-9400-93584F34D914}"/>
              </a:ext>
            </a:extLst>
          </p:cNvPr>
          <p:cNvSpPr txBox="1"/>
          <p:nvPr/>
        </p:nvSpPr>
        <p:spPr>
          <a:xfrm>
            <a:off x="9861962" y="5274493"/>
            <a:ext cx="1645332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kumimoji="1" lang="en-US" altLang="ja-JP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 risk with BXM</a:t>
            </a:r>
            <a:endParaRPr kumimoji="1" lang="ja-JP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690A751F-EF81-7162-D7F6-81878961D2F9}"/>
              </a:ext>
            </a:extLst>
          </p:cNvPr>
          <p:cNvSpPr/>
          <p:nvPr/>
        </p:nvSpPr>
        <p:spPr>
          <a:xfrm>
            <a:off x="9650566" y="5339768"/>
            <a:ext cx="211396" cy="52738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20" name="Arrow: Right 19">
            <a:extLst>
              <a:ext uri="{FF2B5EF4-FFF2-40B4-BE49-F238E27FC236}">
                <a16:creationId xmlns:a16="http://schemas.microsoft.com/office/drawing/2014/main" id="{534D07D2-F99D-B313-7567-CE6ED5BAC830}"/>
              </a:ext>
            </a:extLst>
          </p:cNvPr>
          <p:cNvSpPr/>
          <p:nvPr/>
        </p:nvSpPr>
        <p:spPr>
          <a:xfrm rot="10800000">
            <a:off x="9299691" y="5339766"/>
            <a:ext cx="211396" cy="5273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7D3D8BC-20AA-1C3D-F8E7-08FCB0BDF2C6}"/>
              </a:ext>
            </a:extLst>
          </p:cNvPr>
          <p:cNvSpPr txBox="1"/>
          <p:nvPr/>
        </p:nvSpPr>
        <p:spPr>
          <a:xfrm>
            <a:off x="134405" y="161925"/>
            <a:ext cx="88794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b="1" dirty="0" err="1"/>
              <a:t>eFigure</a:t>
            </a:r>
            <a:r>
              <a:rPr lang="en-NZ" b="1" dirty="0"/>
              <a:t> 1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7C80126B-1069-55D4-4322-445D39BBA350}"/>
              </a:ext>
            </a:extLst>
          </p:cNvPr>
          <p:cNvCxnSpPr>
            <a:cxnSpLocks/>
          </p:cNvCxnSpPr>
          <p:nvPr/>
        </p:nvCxnSpPr>
        <p:spPr>
          <a:xfrm>
            <a:off x="6457636" y="1138853"/>
            <a:ext cx="0" cy="253674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3C5C5228-5980-2999-46BC-7F7FC577C774}"/>
              </a:ext>
            </a:extLst>
          </p:cNvPr>
          <p:cNvCxnSpPr>
            <a:cxnSpLocks/>
          </p:cNvCxnSpPr>
          <p:nvPr/>
        </p:nvCxnSpPr>
        <p:spPr>
          <a:xfrm>
            <a:off x="9613971" y="5131018"/>
            <a:ext cx="0" cy="261488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F0E1BD6D-FC23-9F68-AA3B-F32C108C0E50}"/>
              </a:ext>
            </a:extLst>
          </p:cNvPr>
          <p:cNvSpPr txBox="1"/>
          <p:nvPr/>
        </p:nvSpPr>
        <p:spPr>
          <a:xfrm>
            <a:off x="10751075" y="507868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/>
              <a:t>0.6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4B7EFF4-A65A-4A2D-6411-8C202922FF2D}"/>
              </a:ext>
            </a:extLst>
          </p:cNvPr>
          <p:cNvSpPr txBox="1"/>
          <p:nvPr/>
        </p:nvSpPr>
        <p:spPr>
          <a:xfrm>
            <a:off x="9881531" y="506943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/>
              <a:t>0.2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F89CA47-5879-9CC7-D2C3-0C0F5A1365D7}"/>
              </a:ext>
            </a:extLst>
          </p:cNvPr>
          <p:cNvSpPr txBox="1"/>
          <p:nvPr/>
        </p:nvSpPr>
        <p:spPr>
          <a:xfrm>
            <a:off x="8957281" y="5059828"/>
            <a:ext cx="4523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/>
              <a:t>-0.20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B8DA9A9D-BF57-D8B8-A888-2A1973FC0A39}"/>
              </a:ext>
            </a:extLst>
          </p:cNvPr>
          <p:cNvCxnSpPr>
            <a:cxnSpLocks/>
            <a:endCxn id="7" idx="1"/>
          </p:cNvCxnSpPr>
          <p:nvPr/>
        </p:nvCxnSpPr>
        <p:spPr>
          <a:xfrm>
            <a:off x="7890304" y="5311929"/>
            <a:ext cx="8305" cy="458722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4">
            <a:extLst>
              <a:ext uri="{FF2B5EF4-FFF2-40B4-BE49-F238E27FC236}">
                <a16:creationId xmlns:a16="http://schemas.microsoft.com/office/drawing/2014/main" id="{66184E70-0D12-6267-475F-ABDB3695FC32}"/>
              </a:ext>
            </a:extLst>
          </p:cNvPr>
          <p:cNvSpPr txBox="1"/>
          <p:nvPr/>
        </p:nvSpPr>
        <p:spPr>
          <a:xfrm>
            <a:off x="6246512" y="5130237"/>
            <a:ext cx="2848857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altLang="ja-JP" sz="900" dirty="0"/>
              <a:t>0.03125           0.125           </a:t>
            </a:r>
            <a:r>
              <a:rPr lang="en-NZ" sz="900" dirty="0"/>
              <a:t>  0.5      1        2        4        8       16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A85466E-C667-4726-D3E3-27CC6EFDCE11}"/>
              </a:ext>
            </a:extLst>
          </p:cNvPr>
          <p:cNvSpPr txBox="1"/>
          <p:nvPr/>
        </p:nvSpPr>
        <p:spPr>
          <a:xfrm>
            <a:off x="1244688" y="6419076"/>
            <a:ext cx="102542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0" i="0" dirty="0">
                <a:solidFill>
                  <a:srgbClr val="1C1D1E"/>
                </a:solidFill>
                <a:effectLst/>
                <a:latin typeface="Open Sans regular"/>
              </a:rPr>
              <a:t>Abbreviations: BXM, baloxavir marboxil; CI, confidence interval; IPTW, inverse probability of treatment weighting; OTV, oseltamivir phosphate.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683671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99454e2b-1820-42db-8a31-21c2cea32682" xsi:nil="true"/>
    <lcf76f155ced4ddcb4097134ff3c332f xmlns="46da5964-6c9c-4df9-ab57-3158245ef01b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58B1E18D97635B49AC730E8449F6A3F9" ma:contentTypeVersion="17" ma:contentTypeDescription="新しいドキュメントを作成します。" ma:contentTypeScope="" ma:versionID="c8f53c61d2dae56416a13a41f9879581">
  <xsd:schema xmlns:xsd="http://www.w3.org/2001/XMLSchema" xmlns:xs="http://www.w3.org/2001/XMLSchema" xmlns:p="http://schemas.microsoft.com/office/2006/metadata/properties" xmlns:ns2="46da5964-6c9c-4df9-ab57-3158245ef01b" xmlns:ns3="99454e2b-1820-42db-8a31-21c2cea32682" targetNamespace="http://schemas.microsoft.com/office/2006/metadata/properties" ma:root="true" ma:fieldsID="8f20c2a9e59e28babd77f437d29fe0cf" ns2:_="" ns3:_="">
    <xsd:import namespace="46da5964-6c9c-4df9-ab57-3158245ef01b"/>
    <xsd:import namespace="99454e2b-1820-42db-8a31-21c2cea3268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SearchProperties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LengthInSecond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6da5964-6c9c-4df9-ab57-3158245ef01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3" nillable="true" ma:taxonomy="true" ma:internalName="lcf76f155ced4ddcb4097134ff3c332f" ma:taxonomyFieldName="MediaServiceImageTags" ma:displayName="画像タグ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4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9454e2b-1820-42db-8a31-21c2cea32682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fbdfd1c9-f070-4c30-8b33-627e288229db}" ma:internalName="TaxCatchAll" ma:showField="CatchAllData" ma:web="99454e2b-1820-42db-8a31-21c2cea3268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6C298F3-BB30-4D38-B6DB-494F70AF06C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25A1063-A907-4625-BC7E-6CA4D071DC29}">
  <ds:schemaRefs>
    <ds:schemaRef ds:uri="http://schemas.microsoft.com/office/2006/metadata/properties"/>
    <ds:schemaRef ds:uri="http://schemas.microsoft.com/office/infopath/2007/PartnerControls"/>
    <ds:schemaRef ds:uri="99454e2b-1820-42db-8a31-21c2cea32682"/>
    <ds:schemaRef ds:uri="46da5964-6c9c-4df9-ab57-3158245ef01b"/>
  </ds:schemaRefs>
</ds:datastoreItem>
</file>

<file path=customXml/itemProps3.xml><?xml version="1.0" encoding="utf-8"?>
<ds:datastoreItem xmlns:ds="http://schemas.openxmlformats.org/officeDocument/2006/customXml" ds:itemID="{778E86DF-FA8D-4755-A72D-1B601EF3065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6da5964-6c9c-4df9-ab57-3158245ef01b"/>
    <ds:schemaRef ds:uri="99454e2b-1820-42db-8a31-21c2cea3268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4</Words>
  <Application>Microsoft Office PowerPoint</Application>
  <PresentationFormat>ワイド画面</PresentationFormat>
  <Paragraphs>10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Open Sans regular</vt:lpstr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/>
  <cp:revision>3</cp:revision>
  <dcterms:created xsi:type="dcterms:W3CDTF">2023-10-17T12:18:26Z</dcterms:created>
  <dcterms:modified xsi:type="dcterms:W3CDTF">2024-08-20T02:42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8B1E18D97635B49AC730E8449F6A3F9</vt:lpwstr>
  </property>
  <property fmtid="{D5CDD505-2E9C-101B-9397-08002B2CF9AE}" pid="3" name="MediaServiceImageTags">
    <vt:lpwstr/>
  </property>
</Properties>
</file>